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67" r:id="rId3"/>
    <p:sldId id="268" r:id="rId4"/>
    <p:sldId id="269" r:id="rId5"/>
    <p:sldId id="270" r:id="rId6"/>
    <p:sldId id="271" r:id="rId7"/>
    <p:sldId id="272" r:id="rId8"/>
    <p:sldId id="273" r:id="rId9"/>
    <p:sldId id="274" r:id="rId10"/>
    <p:sldId id="275" r:id="rId11"/>
    <p:sldId id="276" r:id="rId12"/>
    <p:sldId id="277" r:id="rId13"/>
    <p:sldId id="278" r:id="rId14"/>
    <p:sldId id="279" r:id="rId1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89" d="100"/>
          <a:sy n="89" d="100"/>
        </p:scale>
        <p:origin x="466" y="7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430B9-ED14-4E0B-A487-0DCCD4B6BB4C}" type="datetimeFigureOut">
              <a:rPr lang="en-US" smtClean="0"/>
              <a:t>4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988D9F-1855-4F0E-9779-D5C9CC5CA0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88551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430B9-ED14-4E0B-A487-0DCCD4B6BB4C}" type="datetimeFigureOut">
              <a:rPr lang="en-US" smtClean="0"/>
              <a:t>4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988D9F-1855-4F0E-9779-D5C9CC5CA0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73962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430B9-ED14-4E0B-A487-0DCCD4B6BB4C}" type="datetimeFigureOut">
              <a:rPr lang="en-US" smtClean="0"/>
              <a:t>4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988D9F-1855-4F0E-9779-D5C9CC5CA0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88055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430B9-ED14-4E0B-A487-0DCCD4B6BB4C}" type="datetimeFigureOut">
              <a:rPr lang="en-US" smtClean="0"/>
              <a:t>4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988D9F-1855-4F0E-9779-D5C9CC5CA0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90024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430B9-ED14-4E0B-A487-0DCCD4B6BB4C}" type="datetimeFigureOut">
              <a:rPr lang="en-US" smtClean="0"/>
              <a:t>4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988D9F-1855-4F0E-9779-D5C9CC5CA0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71518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430B9-ED14-4E0B-A487-0DCCD4B6BB4C}" type="datetimeFigureOut">
              <a:rPr lang="en-US" smtClean="0"/>
              <a:t>4/1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988D9F-1855-4F0E-9779-D5C9CC5CA0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89783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430B9-ED14-4E0B-A487-0DCCD4B6BB4C}" type="datetimeFigureOut">
              <a:rPr lang="en-US" smtClean="0"/>
              <a:t>4/14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988D9F-1855-4F0E-9779-D5C9CC5CA0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30567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430B9-ED14-4E0B-A487-0DCCD4B6BB4C}" type="datetimeFigureOut">
              <a:rPr lang="en-US" smtClean="0"/>
              <a:t>4/14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988D9F-1855-4F0E-9779-D5C9CC5CA0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21191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430B9-ED14-4E0B-A487-0DCCD4B6BB4C}" type="datetimeFigureOut">
              <a:rPr lang="en-US" smtClean="0"/>
              <a:t>4/14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988D9F-1855-4F0E-9779-D5C9CC5CA0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07151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430B9-ED14-4E0B-A487-0DCCD4B6BB4C}" type="datetimeFigureOut">
              <a:rPr lang="en-US" smtClean="0"/>
              <a:t>4/1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988D9F-1855-4F0E-9779-D5C9CC5CA0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40877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430B9-ED14-4E0B-A487-0DCCD4B6BB4C}" type="datetimeFigureOut">
              <a:rPr lang="en-US" smtClean="0"/>
              <a:t>4/1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988D9F-1855-4F0E-9779-D5C9CC5CA0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75846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01430B9-ED14-4E0B-A487-0DCCD4B6BB4C}" type="datetimeFigureOut">
              <a:rPr lang="en-US" smtClean="0"/>
              <a:t>4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988D9F-1855-4F0E-9779-D5C9CC5CA0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67861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image" Target="../media/image16.emf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2" Type="http://schemas.openxmlformats.org/officeDocument/2006/relationships/image" Target="../media/image18.emf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png"/><Relationship Id="rId2" Type="http://schemas.openxmlformats.org/officeDocument/2006/relationships/image" Target="../media/image20.emf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png"/><Relationship Id="rId2" Type="http://schemas.openxmlformats.org/officeDocument/2006/relationships/image" Target="../media/image22.emf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5.png"/><Relationship Id="rId2" Type="http://schemas.openxmlformats.org/officeDocument/2006/relationships/image" Target="../media/image24.e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emf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8.emf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emf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image" Target="../media/image12.emf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image" Target="../media/image14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2794957"/>
            <a:ext cx="9144000" cy="715005"/>
          </a:xfrm>
        </p:spPr>
        <p:txBody>
          <a:bodyPr>
            <a:normAutofit fontScale="90000"/>
          </a:bodyPr>
          <a:lstStyle/>
          <a:p>
            <a:r>
              <a:rPr lang="en-US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l Figure S4. </a:t>
            </a:r>
            <a:r>
              <a:rPr lang="en-US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GSEA </a:t>
            </a:r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of 16 </a:t>
            </a:r>
            <a:r>
              <a:rPr lang="en-US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transcription factors (TF) - coding </a:t>
            </a:r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genes regulating expression of </a:t>
            </a:r>
            <a:r>
              <a:rPr lang="en-US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377 </a:t>
            </a:r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LTR7- and LTR5_Hs-linked </a:t>
            </a:r>
            <a:r>
              <a:rPr lang="en-US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genes. Related to Table 8.</a:t>
            </a:r>
            <a:endParaRPr 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246588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5400000">
            <a:off x="893620" y="910871"/>
            <a:ext cx="4510223" cy="5123916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3091131" y="0"/>
            <a:ext cx="6096000" cy="646331"/>
          </a:xfrm>
          <a:prstGeom prst="rect">
            <a:avLst/>
          </a:prstGeom>
        </p:spPr>
        <p:txBody>
          <a:bodyPr>
            <a:spAutoFit/>
          </a:bodyPr>
          <a:lstStyle/>
          <a:p>
            <a:pPr algn="ctr"/>
            <a:r>
              <a:rPr lang="en-US" b="1" dirty="0"/>
              <a:t>GSEA of 16 TF coding genes </a:t>
            </a:r>
            <a:r>
              <a:rPr lang="en-US" b="1" dirty="0" smtClean="0"/>
              <a:t>regulating </a:t>
            </a:r>
            <a:r>
              <a:rPr lang="en-US" b="1" dirty="0"/>
              <a:t>expression of </a:t>
            </a:r>
            <a:endParaRPr lang="en-US" b="1" dirty="0" smtClean="0"/>
          </a:p>
          <a:p>
            <a:pPr algn="ctr"/>
            <a:r>
              <a:rPr lang="en-US" b="1" dirty="0" smtClean="0"/>
              <a:t>377 LTR7- and LTR5_Hs-linked genes</a:t>
            </a:r>
            <a:endParaRPr lang="en-US" b="1" dirty="0"/>
          </a:p>
        </p:txBody>
      </p:sp>
      <p:pic>
        <p:nvPicPr>
          <p:cNvPr id="4098" name="Picture 2" descr="https://appyters.maayanlab.cloud/Enrichment_Analysis_Visualizer/3d16d2769a9ddfda36a01c79991eb0b80340b0fb/Enrichr_results_ba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10690" y="2092568"/>
            <a:ext cx="6114964" cy="388620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0" y="0"/>
            <a:ext cx="25519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</a:p>
        </p:txBody>
      </p:sp>
    </p:spTree>
    <p:extLst>
      <p:ext uri="{BB962C8B-B14F-4D97-AF65-F5344CB8AC3E}">
        <p14:creationId xmlns:p14="http://schemas.microsoft.com/office/powerpoint/2010/main" val="3635783974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5400000">
            <a:off x="962101" y="979354"/>
            <a:ext cx="4393726" cy="4879157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3091131" y="0"/>
            <a:ext cx="6096000" cy="646331"/>
          </a:xfrm>
          <a:prstGeom prst="rect">
            <a:avLst/>
          </a:prstGeom>
        </p:spPr>
        <p:txBody>
          <a:bodyPr>
            <a:spAutoFit/>
          </a:bodyPr>
          <a:lstStyle/>
          <a:p>
            <a:pPr algn="ctr"/>
            <a:r>
              <a:rPr lang="en-US" b="1" dirty="0"/>
              <a:t>GSEA of 16 TF coding genes </a:t>
            </a:r>
            <a:r>
              <a:rPr lang="en-US" b="1" dirty="0" smtClean="0"/>
              <a:t>regulating </a:t>
            </a:r>
            <a:r>
              <a:rPr lang="en-US" b="1" dirty="0"/>
              <a:t>expression of </a:t>
            </a:r>
            <a:endParaRPr lang="en-US" b="1" dirty="0" smtClean="0"/>
          </a:p>
          <a:p>
            <a:pPr algn="ctr"/>
            <a:r>
              <a:rPr lang="en-US" b="1" dirty="0" smtClean="0"/>
              <a:t>377 LTR7- and LTR5_Hs-linked genes</a:t>
            </a:r>
            <a:endParaRPr lang="en-US" b="1" dirty="0"/>
          </a:p>
        </p:txBody>
      </p:sp>
      <p:pic>
        <p:nvPicPr>
          <p:cNvPr id="5122" name="Picture 2" descr="https://appyters.maayanlab.cloud/Enrichment_Analysis_Visualizer/e54849b0bc449c5628b277c0b2035689ce9b6c4f/Enrichr_results_ba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598543" y="2044460"/>
            <a:ext cx="6167887" cy="373523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0" y="0"/>
            <a:ext cx="32733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J</a:t>
            </a:r>
          </a:p>
        </p:txBody>
      </p:sp>
    </p:spTree>
    <p:extLst>
      <p:ext uri="{BB962C8B-B14F-4D97-AF65-F5344CB8AC3E}">
        <p14:creationId xmlns:p14="http://schemas.microsoft.com/office/powerpoint/2010/main" val="3350233666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5400000">
            <a:off x="828921" y="872052"/>
            <a:ext cx="4674125" cy="5158422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3091131" y="0"/>
            <a:ext cx="6096000" cy="646331"/>
          </a:xfrm>
          <a:prstGeom prst="rect">
            <a:avLst/>
          </a:prstGeom>
        </p:spPr>
        <p:txBody>
          <a:bodyPr>
            <a:spAutoFit/>
          </a:bodyPr>
          <a:lstStyle/>
          <a:p>
            <a:pPr algn="ctr"/>
            <a:r>
              <a:rPr lang="en-US" b="1" dirty="0"/>
              <a:t>GSEA of 16 TF coding genes </a:t>
            </a:r>
            <a:r>
              <a:rPr lang="en-US" b="1" dirty="0" smtClean="0"/>
              <a:t>regulating </a:t>
            </a:r>
            <a:r>
              <a:rPr lang="en-US" b="1" dirty="0"/>
              <a:t>expression of </a:t>
            </a:r>
            <a:endParaRPr lang="en-US" b="1" dirty="0" smtClean="0"/>
          </a:p>
          <a:p>
            <a:pPr algn="ctr"/>
            <a:r>
              <a:rPr lang="en-US" b="1" dirty="0" smtClean="0"/>
              <a:t>377 LTR7- and LTR5_Hs-linked genes</a:t>
            </a:r>
            <a:endParaRPr lang="en-US" b="1" dirty="0"/>
          </a:p>
        </p:txBody>
      </p:sp>
      <p:pic>
        <p:nvPicPr>
          <p:cNvPr id="2050" name="Picture 2" descr="https://appyters.maayanlab.cloud/Enrichment_Analysis_Visualizer/ae85d295523e5d0ef4b1a24999d9faaf943ce65c/Enrichr_results_ba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641675" y="2074984"/>
            <a:ext cx="6087264" cy="39653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0" y="0"/>
            <a:ext cx="3706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</a:p>
        </p:txBody>
      </p:sp>
    </p:spTree>
    <p:extLst>
      <p:ext uri="{BB962C8B-B14F-4D97-AF65-F5344CB8AC3E}">
        <p14:creationId xmlns:p14="http://schemas.microsoft.com/office/powerpoint/2010/main" val="788245528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5400000">
            <a:off x="1069361" y="1052112"/>
            <a:ext cx="4406707" cy="4893194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3091131" y="0"/>
            <a:ext cx="6096000" cy="646331"/>
          </a:xfrm>
          <a:prstGeom prst="rect">
            <a:avLst/>
          </a:prstGeom>
        </p:spPr>
        <p:txBody>
          <a:bodyPr>
            <a:spAutoFit/>
          </a:bodyPr>
          <a:lstStyle/>
          <a:p>
            <a:pPr algn="ctr"/>
            <a:r>
              <a:rPr lang="en-US" b="1" dirty="0"/>
              <a:t>GSEA of 16 TF coding genes </a:t>
            </a:r>
            <a:r>
              <a:rPr lang="en-US" b="1" dirty="0" smtClean="0"/>
              <a:t>regulating </a:t>
            </a:r>
            <a:r>
              <a:rPr lang="en-US" b="1" dirty="0"/>
              <a:t>expression of </a:t>
            </a:r>
            <a:endParaRPr lang="en-US" b="1" dirty="0" smtClean="0"/>
          </a:p>
          <a:p>
            <a:pPr algn="ctr"/>
            <a:r>
              <a:rPr lang="en-US" b="1" dirty="0" smtClean="0"/>
              <a:t>377 LTR7- and LTR5_Hs-linked genes</a:t>
            </a:r>
            <a:endParaRPr lang="en-US" b="1" dirty="0"/>
          </a:p>
        </p:txBody>
      </p:sp>
      <p:pic>
        <p:nvPicPr>
          <p:cNvPr id="3074" name="Picture 2" descr="Enrichr_results_bar.png (1360×746)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19313" y="2234242"/>
            <a:ext cx="5701896" cy="374386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TextBox 5"/>
          <p:cNvSpPr txBox="1"/>
          <p:nvPr/>
        </p:nvSpPr>
        <p:spPr>
          <a:xfrm>
            <a:off x="0" y="0"/>
            <a:ext cx="34176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</a:p>
        </p:txBody>
      </p:sp>
    </p:spTree>
    <p:extLst>
      <p:ext uri="{BB962C8B-B14F-4D97-AF65-F5344CB8AC3E}">
        <p14:creationId xmlns:p14="http://schemas.microsoft.com/office/powerpoint/2010/main" val="2093570615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5400000">
            <a:off x="1032154" y="816491"/>
            <a:ext cx="4432585" cy="5079761"/>
          </a:xfrm>
          <a:prstGeom prst="rect">
            <a:avLst/>
          </a:prstGeom>
        </p:spPr>
      </p:pic>
      <p:pic>
        <p:nvPicPr>
          <p:cNvPr id="1026" name="Picture 2" descr="https://appyters.maayanlab.cloud/Enrichment_Analysis_Visualizer/a5304e8b5608e02c80d0b73f00c1be9cd882361a/Enrichr_results_ba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88327" y="2044460"/>
            <a:ext cx="5926345" cy="384738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Rectangle 2"/>
          <p:cNvSpPr/>
          <p:nvPr/>
        </p:nvSpPr>
        <p:spPr>
          <a:xfrm>
            <a:off x="3091131" y="0"/>
            <a:ext cx="6096000" cy="646331"/>
          </a:xfrm>
          <a:prstGeom prst="rect">
            <a:avLst/>
          </a:prstGeom>
        </p:spPr>
        <p:txBody>
          <a:bodyPr>
            <a:spAutoFit/>
          </a:bodyPr>
          <a:lstStyle/>
          <a:p>
            <a:pPr algn="ctr"/>
            <a:r>
              <a:rPr lang="en-US" b="1" dirty="0"/>
              <a:t>GSEA of 16 TF coding genes </a:t>
            </a:r>
            <a:r>
              <a:rPr lang="en-US" b="1" dirty="0" smtClean="0"/>
              <a:t>regulating </a:t>
            </a:r>
            <a:r>
              <a:rPr lang="en-US" b="1" dirty="0"/>
              <a:t>expression of </a:t>
            </a:r>
            <a:endParaRPr lang="en-US" b="1" dirty="0" smtClean="0"/>
          </a:p>
          <a:p>
            <a:pPr algn="ctr"/>
            <a:r>
              <a:rPr lang="en-US" b="1" dirty="0" smtClean="0"/>
              <a:t>377 LTR7- and LTR5_Hs-linked genes</a:t>
            </a:r>
            <a:endParaRPr lang="en-US" b="1" dirty="0"/>
          </a:p>
        </p:txBody>
      </p:sp>
      <p:sp>
        <p:nvSpPr>
          <p:cNvPr id="5" name="TextBox 4"/>
          <p:cNvSpPr txBox="1"/>
          <p:nvPr/>
        </p:nvSpPr>
        <p:spPr>
          <a:xfrm>
            <a:off x="0" y="0"/>
            <a:ext cx="39786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</a:p>
        </p:txBody>
      </p:sp>
    </p:spTree>
    <p:extLst>
      <p:ext uri="{BB962C8B-B14F-4D97-AF65-F5344CB8AC3E}">
        <p14:creationId xmlns:p14="http://schemas.microsoft.com/office/powerpoint/2010/main" val="85118365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75118" y="1024947"/>
            <a:ext cx="5631003" cy="4918651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3114137" y="0"/>
            <a:ext cx="497744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b="1" i="0" u="none" strike="noStrike" dirty="0" smtClean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GSEA of 377 LTR7- and LTR5_Hs-linked  genes</a:t>
            </a:r>
          </a:p>
          <a:p>
            <a:pPr algn="ctr"/>
            <a:r>
              <a:rPr lang="en-US" b="1" dirty="0" smtClean="0">
                <a:solidFill>
                  <a:srgbClr val="000000"/>
                </a:solidFill>
                <a:latin typeface="Calibri" panose="020F0502020204030204" pitchFamily="34" charset="0"/>
              </a:rPr>
              <a:t>TF perturbations followed by expression database</a:t>
            </a:r>
            <a:endParaRPr lang="en-US" b="1" i="0" u="none" strike="noStrike" dirty="0" smtClean="0">
              <a:solidFill>
                <a:srgbClr val="000000"/>
              </a:solidFill>
              <a:effectLst/>
              <a:latin typeface="Calibri" panose="020F0502020204030204" pitchFamily="34" charset="0"/>
            </a:endParaRPr>
          </a:p>
        </p:txBody>
      </p:sp>
      <p:graphicFrame>
        <p:nvGraphicFramePr>
          <p:cNvPr id="4" name="Table 3"/>
          <p:cNvGraphicFramePr>
            <a:graphicFrameLocks noGrp="1"/>
          </p:cNvGraphicFramePr>
          <p:nvPr/>
        </p:nvGraphicFramePr>
        <p:xfrm>
          <a:off x="7746521" y="1596597"/>
          <a:ext cx="2613804" cy="418338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613804"/>
              </a:tblGrid>
              <a:tr h="19812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u="none" strike="noStrike" dirty="0" smtClean="0">
                          <a:effectLst/>
                        </a:rPr>
                        <a:t>16 TF-coding</a:t>
                      </a:r>
                      <a:r>
                        <a:rPr lang="en-US" sz="1400" b="1" u="none" strike="noStrike" baseline="0" dirty="0" smtClean="0">
                          <a:effectLst/>
                        </a:rPr>
                        <a:t> genes regulating expression LTR7- and LTR5_Hs-linked genes</a:t>
                      </a:r>
                      <a:endParaRPr lang="en-US" sz="1400" b="1" i="0" u="none" strike="noStrike" dirty="0">
                        <a:solidFill>
                          <a:srgbClr val="FF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19812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u="none" strike="noStrike">
                          <a:effectLst/>
                        </a:rPr>
                        <a:t>BACH2</a:t>
                      </a:r>
                      <a:endParaRPr lang="en-US" sz="14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19812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u="none" strike="noStrike">
                          <a:effectLst/>
                        </a:rPr>
                        <a:t>BCL11B</a:t>
                      </a:r>
                      <a:endParaRPr lang="en-US" sz="14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1828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u="none" strike="noStrike">
                          <a:effectLst/>
                        </a:rPr>
                        <a:t>DNMT1</a:t>
                      </a:r>
                      <a:endParaRPr lang="en-US" sz="14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1828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u="none" strike="noStrike" dirty="0">
                          <a:effectLst/>
                        </a:rPr>
                        <a:t>EOMES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1828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u="none" strike="noStrike">
                          <a:effectLst/>
                        </a:rPr>
                        <a:t>HMGA2</a:t>
                      </a:r>
                      <a:endParaRPr lang="en-US" sz="14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1828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u="none" strike="noStrike">
                          <a:effectLst/>
                        </a:rPr>
                        <a:t>MYC</a:t>
                      </a:r>
                      <a:endParaRPr lang="en-US" sz="14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1828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u="none" strike="noStrike">
                          <a:effectLst/>
                        </a:rPr>
                        <a:t>NKX25</a:t>
                      </a:r>
                      <a:endParaRPr lang="en-US" sz="14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1828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u="none" strike="noStrike" dirty="0">
                          <a:effectLst/>
                        </a:rPr>
                        <a:t>REST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1828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u="none" strike="noStrike">
                          <a:effectLst/>
                        </a:rPr>
                        <a:t>SATB1</a:t>
                      </a:r>
                      <a:endParaRPr lang="en-US" sz="14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1828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u="none" strike="noStrike">
                          <a:effectLst/>
                        </a:rPr>
                        <a:t>SOX2</a:t>
                      </a:r>
                      <a:endParaRPr lang="en-US" sz="14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1828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u="none" strike="noStrike">
                          <a:effectLst/>
                        </a:rPr>
                        <a:t>SOX3</a:t>
                      </a:r>
                      <a:endParaRPr lang="en-US" sz="14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1828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u="none" strike="noStrike">
                          <a:effectLst/>
                        </a:rPr>
                        <a:t>TET1</a:t>
                      </a:r>
                      <a:endParaRPr lang="en-US" sz="14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1828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u="none" strike="noStrike">
                          <a:effectLst/>
                        </a:rPr>
                        <a:t>TET2</a:t>
                      </a:r>
                      <a:endParaRPr lang="en-US" sz="14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1828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u="none" strike="noStrike">
                          <a:effectLst/>
                        </a:rPr>
                        <a:t>TET3</a:t>
                      </a:r>
                      <a:endParaRPr lang="en-US" sz="14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1828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u="none" strike="noStrike">
                          <a:effectLst/>
                        </a:rPr>
                        <a:t>TWIST1</a:t>
                      </a:r>
                      <a:endParaRPr lang="en-US" sz="1400" b="1" i="0" u="none" strike="noStrike">
                        <a:solidFill>
                          <a:srgbClr val="FF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1828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u="none" strike="noStrike" dirty="0">
                          <a:effectLst/>
                        </a:rPr>
                        <a:t>VDR</a:t>
                      </a:r>
                      <a:endParaRPr lang="en-US" sz="1400" b="1" i="0" u="none" strike="noStrike" dirty="0">
                        <a:solidFill>
                          <a:srgbClr val="FF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</a:tbl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0" y="0"/>
            <a:ext cx="3706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9542305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3091131" y="0"/>
            <a:ext cx="6096000" cy="646331"/>
          </a:xfrm>
          <a:prstGeom prst="rect">
            <a:avLst/>
          </a:prstGeom>
        </p:spPr>
        <p:txBody>
          <a:bodyPr>
            <a:spAutoFit/>
          </a:bodyPr>
          <a:lstStyle/>
          <a:p>
            <a:pPr algn="ctr"/>
            <a:r>
              <a:rPr lang="en-US" b="1" dirty="0"/>
              <a:t>GSEA of 16 TF coding genes </a:t>
            </a:r>
            <a:r>
              <a:rPr lang="en-US" b="1" dirty="0" smtClean="0"/>
              <a:t>regulating </a:t>
            </a:r>
            <a:r>
              <a:rPr lang="en-US" b="1" dirty="0"/>
              <a:t>expression of </a:t>
            </a:r>
            <a:endParaRPr lang="en-US" b="1" dirty="0" smtClean="0"/>
          </a:p>
          <a:p>
            <a:pPr algn="ctr"/>
            <a:r>
              <a:rPr lang="en-US" b="1" dirty="0" smtClean="0"/>
              <a:t>377 LTR7- and LTR5_Hs-linked genes</a:t>
            </a:r>
            <a:endParaRPr lang="en-US" b="1" dirty="0"/>
          </a:p>
        </p:txBody>
      </p:sp>
      <p:pic>
        <p:nvPicPr>
          <p:cNvPr id="11266" name="Picture 2" descr="https://appyters.maayanlab.cloud/Enrichment_Analysis_Visualizer/c255bd0d4224a71ad7b874fa667fb8a7a77108c3/Enrichr_results_bar.pn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615796" y="2156604"/>
            <a:ext cx="6142008" cy="384738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5400000">
            <a:off x="942143" y="1065799"/>
            <a:ext cx="4497245" cy="4850060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0" y="0"/>
            <a:ext cx="3706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7880602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3091131" y="0"/>
            <a:ext cx="6096000" cy="646331"/>
          </a:xfrm>
          <a:prstGeom prst="rect">
            <a:avLst/>
          </a:prstGeom>
        </p:spPr>
        <p:txBody>
          <a:bodyPr>
            <a:spAutoFit/>
          </a:bodyPr>
          <a:lstStyle/>
          <a:p>
            <a:pPr algn="ctr"/>
            <a:r>
              <a:rPr lang="en-US" b="1" dirty="0"/>
              <a:t>GSEA of 16 TF coding genes </a:t>
            </a:r>
            <a:r>
              <a:rPr lang="en-US" b="1" dirty="0" smtClean="0"/>
              <a:t>regulating </a:t>
            </a:r>
            <a:r>
              <a:rPr lang="en-US" b="1" dirty="0"/>
              <a:t>expression of </a:t>
            </a:r>
            <a:endParaRPr lang="en-US" b="1" dirty="0" smtClean="0"/>
          </a:p>
          <a:p>
            <a:pPr algn="ctr"/>
            <a:r>
              <a:rPr lang="en-US" b="1" dirty="0" smtClean="0"/>
              <a:t>377 LTR7- and LTR5_Hs-linked genes</a:t>
            </a:r>
            <a:endParaRPr lang="en-US" b="1" dirty="0"/>
          </a:p>
        </p:txBody>
      </p:sp>
      <p:pic>
        <p:nvPicPr>
          <p:cNvPr id="12290" name="Picture 2" descr="https://appyters.maayanlab.cloud/Enrichment_Analysis_Visualizer/83a9c8c20f7d95473e26e045a23ccc290f0582b6/Enrichr_results_bar.pn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495026" y="1731006"/>
            <a:ext cx="6137752" cy="370579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5400000">
            <a:off x="952553" y="678017"/>
            <a:ext cx="4357847" cy="4727098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0" y="0"/>
            <a:ext cx="3706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313897183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5400000">
            <a:off x="834658" y="955428"/>
            <a:ext cx="4485736" cy="4852254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3091131" y="0"/>
            <a:ext cx="6096000" cy="646331"/>
          </a:xfrm>
          <a:prstGeom prst="rect">
            <a:avLst/>
          </a:prstGeom>
        </p:spPr>
        <p:txBody>
          <a:bodyPr>
            <a:spAutoFit/>
          </a:bodyPr>
          <a:lstStyle/>
          <a:p>
            <a:pPr algn="ctr"/>
            <a:r>
              <a:rPr lang="en-US" b="1" dirty="0"/>
              <a:t>GSEA of 16 TF coding genes </a:t>
            </a:r>
            <a:r>
              <a:rPr lang="en-US" b="1" dirty="0" smtClean="0"/>
              <a:t>regulating </a:t>
            </a:r>
            <a:r>
              <a:rPr lang="en-US" b="1" dirty="0"/>
              <a:t>expression of </a:t>
            </a:r>
            <a:endParaRPr lang="en-US" b="1" dirty="0" smtClean="0"/>
          </a:p>
          <a:p>
            <a:pPr algn="ctr"/>
            <a:r>
              <a:rPr lang="en-US" b="1" dirty="0" smtClean="0"/>
              <a:t>377 LTR7- and LTR5_Hs-linked genes</a:t>
            </a:r>
            <a:endParaRPr lang="en-US" b="1" dirty="0"/>
          </a:p>
        </p:txBody>
      </p:sp>
      <p:pic>
        <p:nvPicPr>
          <p:cNvPr id="10242" name="Picture 2" descr="https://appyters.maayanlab.cloud/Enrichment_Analysis_Visualizer/354122ad787a23e7e3f1d00fb8f7c7082ac81403/Enrichr_results_ba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503653" y="2019826"/>
            <a:ext cx="6142007" cy="386338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0" y="0"/>
            <a:ext cx="3706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419939348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5400000">
            <a:off x="1142690" y="978786"/>
            <a:ext cx="4139286" cy="4944954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3091131" y="0"/>
            <a:ext cx="6096000" cy="646331"/>
          </a:xfrm>
          <a:prstGeom prst="rect">
            <a:avLst/>
          </a:prstGeom>
        </p:spPr>
        <p:txBody>
          <a:bodyPr>
            <a:spAutoFit/>
          </a:bodyPr>
          <a:lstStyle/>
          <a:p>
            <a:pPr algn="ctr"/>
            <a:r>
              <a:rPr lang="en-US" b="1" dirty="0"/>
              <a:t>GSEA of 16 TF coding genes </a:t>
            </a:r>
            <a:r>
              <a:rPr lang="en-US" b="1" dirty="0" smtClean="0"/>
              <a:t>regulating </a:t>
            </a:r>
            <a:r>
              <a:rPr lang="en-US" b="1" dirty="0"/>
              <a:t>expression of </a:t>
            </a:r>
            <a:endParaRPr lang="en-US" b="1" dirty="0" smtClean="0"/>
          </a:p>
          <a:p>
            <a:pPr algn="ctr"/>
            <a:r>
              <a:rPr lang="en-US" b="1" dirty="0" smtClean="0"/>
              <a:t>377 LTR7- and LTR5_Hs-linked genes</a:t>
            </a:r>
            <a:endParaRPr lang="en-US" b="1" dirty="0"/>
          </a:p>
        </p:txBody>
      </p:sp>
      <p:pic>
        <p:nvPicPr>
          <p:cNvPr id="8194" name="Picture 2" descr="https://appyters.maayanlab.cloud/Enrichment_Analysis_Visualizer/23699521acf88c34e220688225def66c8ff06418/Enrichr_results_ba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684811" y="2221913"/>
            <a:ext cx="6090246" cy="352328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0" y="0"/>
            <a:ext cx="35618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</p:spTree>
    <p:extLst>
      <p:ext uri="{BB962C8B-B14F-4D97-AF65-F5344CB8AC3E}">
        <p14:creationId xmlns:p14="http://schemas.microsoft.com/office/powerpoint/2010/main" val="269615842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5400000">
            <a:off x="998743" y="1093636"/>
            <a:ext cx="4225551" cy="4974047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3091131" y="0"/>
            <a:ext cx="6096000" cy="646331"/>
          </a:xfrm>
          <a:prstGeom prst="rect">
            <a:avLst/>
          </a:prstGeom>
        </p:spPr>
        <p:txBody>
          <a:bodyPr>
            <a:spAutoFit/>
          </a:bodyPr>
          <a:lstStyle/>
          <a:p>
            <a:pPr algn="ctr"/>
            <a:r>
              <a:rPr lang="en-US" b="1" dirty="0"/>
              <a:t>GSEA of 16 TF coding genes </a:t>
            </a:r>
            <a:r>
              <a:rPr lang="en-US" b="1" dirty="0" smtClean="0"/>
              <a:t>regulating </a:t>
            </a:r>
            <a:r>
              <a:rPr lang="en-US" b="1" dirty="0"/>
              <a:t>expression of </a:t>
            </a:r>
            <a:endParaRPr lang="en-US" b="1" dirty="0" smtClean="0"/>
          </a:p>
          <a:p>
            <a:pPr algn="ctr"/>
            <a:r>
              <a:rPr lang="en-US" b="1" dirty="0" smtClean="0"/>
              <a:t>377 LTR7- and LTR5_Hs-linked genes</a:t>
            </a:r>
            <a:endParaRPr lang="en-US" b="1" dirty="0"/>
          </a:p>
        </p:txBody>
      </p:sp>
      <p:pic>
        <p:nvPicPr>
          <p:cNvPr id="9218" name="Picture 2" descr="https://appyters.maayanlab.cloud/Enrichment_Analysis_Visualizer/61ebf48f8ead60e20fdd03882b009d32e74ba1af/Enrichr_results_ba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598542" y="2304752"/>
            <a:ext cx="5874590" cy="361296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0" y="0"/>
            <a:ext cx="34176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</p:spTree>
    <p:extLst>
      <p:ext uri="{BB962C8B-B14F-4D97-AF65-F5344CB8AC3E}">
        <p14:creationId xmlns:p14="http://schemas.microsoft.com/office/powerpoint/2010/main" val="52143768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5400000">
            <a:off x="789977" y="952721"/>
            <a:ext cx="4566021" cy="4949916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3091131" y="0"/>
            <a:ext cx="6096000" cy="646331"/>
          </a:xfrm>
          <a:prstGeom prst="rect">
            <a:avLst/>
          </a:prstGeom>
        </p:spPr>
        <p:txBody>
          <a:bodyPr>
            <a:spAutoFit/>
          </a:bodyPr>
          <a:lstStyle/>
          <a:p>
            <a:pPr algn="ctr"/>
            <a:r>
              <a:rPr lang="en-US" b="1" dirty="0"/>
              <a:t>GSEA of 16 TF coding genes </a:t>
            </a:r>
            <a:r>
              <a:rPr lang="en-US" b="1" dirty="0" smtClean="0"/>
              <a:t>regulating </a:t>
            </a:r>
            <a:r>
              <a:rPr lang="en-US" b="1" dirty="0"/>
              <a:t>expression of </a:t>
            </a:r>
            <a:endParaRPr lang="en-US" b="1" dirty="0" smtClean="0"/>
          </a:p>
          <a:p>
            <a:pPr algn="ctr"/>
            <a:r>
              <a:rPr lang="en-US" b="1" dirty="0" smtClean="0"/>
              <a:t>377 LTR7- and LTR5_Hs-linked genes</a:t>
            </a:r>
            <a:endParaRPr lang="en-US" b="1" dirty="0"/>
          </a:p>
        </p:txBody>
      </p:sp>
      <p:pic>
        <p:nvPicPr>
          <p:cNvPr id="6146" name="Picture 2" descr="https://appyters.maayanlab.cloud/Enrichment_Analysis_Visualizer/b512b15f8f676f46d5ab83188a6f617be6f78eb0/Enrichr_results_ba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547947" y="2035835"/>
            <a:ext cx="6296122" cy="392501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0" y="0"/>
            <a:ext cx="38343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</p:spTree>
    <p:extLst>
      <p:ext uri="{BB962C8B-B14F-4D97-AF65-F5344CB8AC3E}">
        <p14:creationId xmlns:p14="http://schemas.microsoft.com/office/powerpoint/2010/main" val="2493566872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5400000">
            <a:off x="943751" y="1073149"/>
            <a:ext cx="4488617" cy="5027999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3091131" y="0"/>
            <a:ext cx="6096000" cy="646331"/>
          </a:xfrm>
          <a:prstGeom prst="rect">
            <a:avLst/>
          </a:prstGeom>
        </p:spPr>
        <p:txBody>
          <a:bodyPr>
            <a:spAutoFit/>
          </a:bodyPr>
          <a:lstStyle/>
          <a:p>
            <a:pPr algn="ctr"/>
            <a:r>
              <a:rPr lang="en-US" b="1" dirty="0"/>
              <a:t>GSEA of 16 TF coding genes </a:t>
            </a:r>
            <a:r>
              <a:rPr lang="en-US" b="1" dirty="0" smtClean="0"/>
              <a:t>regulating </a:t>
            </a:r>
            <a:r>
              <a:rPr lang="en-US" b="1" dirty="0"/>
              <a:t>expression of </a:t>
            </a:r>
            <a:endParaRPr lang="en-US" b="1" dirty="0" smtClean="0"/>
          </a:p>
          <a:p>
            <a:pPr algn="ctr"/>
            <a:r>
              <a:rPr lang="en-US" b="1" dirty="0" smtClean="0"/>
              <a:t>377 LTR7- and LTR5_Hs-linked genes</a:t>
            </a:r>
            <a:endParaRPr lang="en-US" b="1" dirty="0"/>
          </a:p>
        </p:txBody>
      </p:sp>
      <p:pic>
        <p:nvPicPr>
          <p:cNvPr id="7170" name="Picture 2" descr="https://appyters.maayanlab.cloud/Enrichment_Analysis_Visualizer/85cd54c080154683feb93ea06c1c84e4d3517a1a/Enrichr_results_ba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02060" y="2270544"/>
            <a:ext cx="5995360" cy="378519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0" y="0"/>
            <a:ext cx="3706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endParaRPr 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775866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9</TotalTime>
  <Words>248</Words>
  <Application>Microsoft Office PowerPoint</Application>
  <PresentationFormat>Widescreen</PresentationFormat>
  <Paragraphs>57</Paragraphs>
  <Slides>1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4</vt:i4>
      </vt:variant>
    </vt:vector>
  </HeadingPairs>
  <TitlesOfParts>
    <vt:vector size="18" baseType="lpstr">
      <vt:lpstr>Arial</vt:lpstr>
      <vt:lpstr>Calibri</vt:lpstr>
      <vt:lpstr>Calibri Light</vt:lpstr>
      <vt:lpstr>Office Theme</vt:lpstr>
      <vt:lpstr>Supplemental Figure S4. GSEA of 16 transcription factors (TF) - coding genes regulating expression of 377 LTR7- and LTR5_Hs-linked genes. Related to Table 8.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377 LTR7-linked  genes among 935 LTR5_Hs linked genes</dc:title>
  <dc:creator>Guennadi Glinskii</dc:creator>
  <cp:lastModifiedBy>Guennadi Glinskii</cp:lastModifiedBy>
  <cp:revision>19</cp:revision>
  <dcterms:created xsi:type="dcterms:W3CDTF">2022-03-05T10:12:02Z</dcterms:created>
  <dcterms:modified xsi:type="dcterms:W3CDTF">2022-04-14T08:41:44Z</dcterms:modified>
</cp:coreProperties>
</file>